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4677965-3420-22CE-D4FA-AC3DBA3388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618" y="3815971"/>
            <a:ext cx="3312198" cy="331219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C8670CE-00E2-E6F8-5E3A-C7ACFFAAE1C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0179"/>
          <a:stretch>
            <a:fillRect/>
          </a:stretch>
        </p:blipFill>
        <p:spPr>
          <a:xfrm>
            <a:off x="3429000" y="455216"/>
            <a:ext cx="2975071" cy="3312198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5EBD459B-6680-02A8-AC1F-DFD1CCC4C50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10179"/>
          <a:stretch>
            <a:fillRect/>
          </a:stretch>
        </p:blipFill>
        <p:spPr>
          <a:xfrm>
            <a:off x="453929" y="455216"/>
            <a:ext cx="2975071" cy="331219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3F1D6DC-ADB2-4C7C-0634-6FA19275FB86}"/>
              </a:ext>
            </a:extLst>
          </p:cNvPr>
          <p:cNvSpPr txBox="1"/>
          <p:nvPr/>
        </p:nvSpPr>
        <p:spPr>
          <a:xfrm>
            <a:off x="512618" y="7176726"/>
            <a:ext cx="610985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8 Fig. The relationship between MEgrey60  and PC1</a:t>
            </a:r>
            <a:r>
              <a:rPr lang="en-US" altLang="ja-JP" sz="1400" b="1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NP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. PC1 scores for each individual were obtained using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dapt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46]. Three genetic groups were shown in blue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yellow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ote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kumimoji="1"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and red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ku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 </a:t>
            </a:r>
            <a:endParaRPr lang="en-US" altLang="ja-JP" sz="1400" b="1" kern="100" baseline="-250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834D460-FBCD-48F3-5C4F-FF623E91FB82}"/>
              </a:ext>
            </a:extLst>
          </p:cNvPr>
          <p:cNvSpPr txBox="1"/>
          <p:nvPr/>
        </p:nvSpPr>
        <p:spPr>
          <a:xfrm>
            <a:off x="2956000" y="320770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BR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34E8F69-74CD-9D7D-A006-814E6A161BFC}"/>
              </a:ext>
            </a:extLst>
          </p:cNvPr>
          <p:cNvSpPr txBox="1"/>
          <p:nvPr/>
        </p:nvSpPr>
        <p:spPr>
          <a:xfrm>
            <a:off x="5867187" y="3207702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KMT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8303C31-4CBF-245F-9FCE-F53541E97E39}"/>
              </a:ext>
            </a:extLst>
          </p:cNvPr>
          <p:cNvSpPr txBox="1"/>
          <p:nvPr/>
        </p:nvSpPr>
        <p:spPr>
          <a:xfrm>
            <a:off x="2900019" y="6565121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MYG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8696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01</TotalTime>
  <Words>44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2</cp:revision>
  <cp:lastPrinted>2023-10-10T08:11:58Z</cp:lastPrinted>
  <dcterms:created xsi:type="dcterms:W3CDTF">2023-07-12T06:47:41Z</dcterms:created>
  <dcterms:modified xsi:type="dcterms:W3CDTF">2025-08-29T07:30:13Z</dcterms:modified>
  <cp:category/>
</cp:coreProperties>
</file>